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jpeg" ContentType="image/jpeg"/>
  <Override PartName="/ppt/media/image11.jpeg" ContentType="image/jpeg"/>
  <Override PartName="/ppt/media/image9.jpeg" ContentType="image/jpeg"/>
  <Override PartName="/ppt/media/image15.wmf" ContentType="image/x-wmf"/>
  <Override PartName="/ppt/media/image1.png" ContentType="image/png"/>
  <Override PartName="/ppt/media/image3.jpeg" ContentType="image/jpeg"/>
  <Override PartName="/ppt/media/image2.png" ContentType="image/png"/>
  <Override PartName="/ppt/media/image4.jpeg" ContentType="image/jpeg"/>
  <Override PartName="/ppt/media/image5.jpeg" ContentType="image/jpeg"/>
  <Override PartName="/ppt/media/image10.jpeg" ContentType="image/jpeg"/>
  <Override PartName="/ppt/media/image6.png" ContentType="image/png"/>
  <Override PartName="/ppt/media/image7.jpeg" ContentType="image/jpeg"/>
  <Override PartName="/ppt/media/image12.jpeg" ContentType="image/jpeg"/>
  <Override PartName="/ppt/media/image14.jpeg" ContentType="image/jpeg"/>
  <Override PartName="/ppt/media/image16.wmf" ContentType="image/x-wmf"/>
  <Override PartName="/ppt/media/image8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7640300" cy="1620043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749600" y="1142640"/>
            <a:ext cx="33588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r>
              <a:rPr b="0" lang="en-US" sz="84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87C165-2A10-4168-B398-6E95BF5DF1AB}" type="slidenum"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sldImg"/>
          </p:nvPr>
        </p:nvSpPr>
        <p:spPr>
          <a:xfrm>
            <a:off x="1749600" y="1143000"/>
            <a:ext cx="3358800" cy="3086280"/>
          </a:xfrm>
          <a:prstGeom prst="rect">
            <a:avLst/>
          </a:prstGeom>
          <a:ln w="0">
            <a:noFill/>
          </a:ln>
        </p:spPr>
      </p:sp>
      <p:sp>
        <p:nvSpPr>
          <p:cNvPr id="98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  <a:ea typeface="宋体"/>
            </a:endParaRPr>
          </a:p>
        </p:txBody>
      </p:sp>
      <p:sp>
        <p:nvSpPr>
          <p:cNvPr id="99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0D1EA2D-4B95-47B0-8FBE-A53F706EF272}" type="slidenum"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6701C1-0C0E-4AE1-9F9F-20A23382DD9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212480" y="861480"/>
            <a:ext cx="1521468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212480" y="4312800"/>
            <a:ext cx="1521468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212480" y="9681840"/>
            <a:ext cx="1521468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4E1CDA-214D-4151-8821-1F4F333FBA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212480" y="861480"/>
            <a:ext cx="1521468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212480" y="4312800"/>
            <a:ext cx="742464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9008640" y="4312800"/>
            <a:ext cx="742464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212480" y="9681840"/>
            <a:ext cx="742464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9008640" y="9681840"/>
            <a:ext cx="742464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9688B2-5E1D-434C-AA7C-3B8DCEB5D03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212480" y="861480"/>
            <a:ext cx="1521468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212480" y="4312800"/>
            <a:ext cx="489888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6356520" y="4312800"/>
            <a:ext cx="489888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1500920" y="4312800"/>
            <a:ext cx="489888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212480" y="9681840"/>
            <a:ext cx="489888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6356520" y="9681840"/>
            <a:ext cx="489888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1500920" y="9681840"/>
            <a:ext cx="489888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697936-886B-4A4A-B9E3-2A5F55CDB61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212480" y="861480"/>
            <a:ext cx="1521468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212480" y="4312800"/>
            <a:ext cx="15214680" cy="10279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925"/>
              </a:spcBef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C930D9-20AB-4D1B-948C-1B1BF6C5EE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212480" y="861480"/>
            <a:ext cx="1521468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212480" y="4312800"/>
            <a:ext cx="15214680" cy="102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BD5BC8-089E-472D-8F6A-4F602D08C4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212480" y="861480"/>
            <a:ext cx="1521468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212480" y="4312800"/>
            <a:ext cx="7424640" cy="102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9008640" y="4312800"/>
            <a:ext cx="7424640" cy="102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DF138B-50FD-4A78-8A66-E6BD6C3270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212480" y="861480"/>
            <a:ext cx="1521468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22EEA0-64E8-4C04-8BBA-EE8E98986F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212480" y="861480"/>
            <a:ext cx="15214680" cy="14520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925"/>
              </a:spcBef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5A9344-AEC7-4E8F-861F-F35A0DC279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212480" y="861480"/>
            <a:ext cx="1521468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212480" y="4312800"/>
            <a:ext cx="742464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9008640" y="4312800"/>
            <a:ext cx="7424640" cy="102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212480" y="9681840"/>
            <a:ext cx="742464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7A50B5-6DA5-4D40-85B8-37B3F49F0D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212480" y="861480"/>
            <a:ext cx="1521468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212480" y="4312800"/>
            <a:ext cx="7424640" cy="102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9008640" y="4312800"/>
            <a:ext cx="742464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9008640" y="9681840"/>
            <a:ext cx="742464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E1BEBF-3CEE-4200-9976-26AA2A4249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212480" y="861480"/>
            <a:ext cx="1521468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212480" y="4312800"/>
            <a:ext cx="742464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9008640" y="4312800"/>
            <a:ext cx="742464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212480" y="9681840"/>
            <a:ext cx="15214680" cy="490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925"/>
              </a:spcBef>
              <a:buNone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EED633-39E3-4DE6-BD7D-D0696BB73E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212480" y="861480"/>
            <a:ext cx="15214680" cy="313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r>
              <a:rPr b="0" lang="en-US" sz="8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8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212480" y="4312800"/>
            <a:ext cx="15214680" cy="102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439560" indent="-439560">
              <a:lnSpc>
                <a:spcPct val="90000"/>
              </a:lnSpc>
              <a:spcBef>
                <a:spcPts val="1925"/>
              </a:spcBef>
              <a:buClr>
                <a:srgbClr val="000000"/>
              </a:buClr>
              <a:buFont typeface="Arial"/>
              <a:buChar char="•"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r>
              <a:rPr b="0" lang="en-US" sz="54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  <a:p>
            <a:pPr lvl="1" marL="1322280" indent="-439560">
              <a:lnSpc>
                <a:spcPct val="90000"/>
              </a:lnSpc>
              <a:spcBef>
                <a:spcPts val="1925"/>
              </a:spcBef>
              <a:buClr>
                <a:srgbClr val="000000"/>
              </a:buClr>
              <a:buFont typeface="Arial"/>
              <a:buChar char="•"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r>
              <a:rPr b="0" lang="en-US" sz="54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  <a:p>
            <a:pPr lvl="2" marL="2205000" indent="-439560">
              <a:lnSpc>
                <a:spcPct val="90000"/>
              </a:lnSpc>
              <a:spcBef>
                <a:spcPts val="1925"/>
              </a:spcBef>
              <a:buClr>
                <a:srgbClr val="000000"/>
              </a:buClr>
              <a:buFont typeface="Arial"/>
              <a:buChar char="•"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r>
              <a:rPr b="0" lang="en-US" sz="54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  <a:p>
            <a:pPr lvl="3" marL="3086280" indent="-439920">
              <a:lnSpc>
                <a:spcPct val="90000"/>
              </a:lnSpc>
              <a:spcBef>
                <a:spcPts val="1925"/>
              </a:spcBef>
              <a:buClr>
                <a:srgbClr val="000000"/>
              </a:buClr>
              <a:buFont typeface="Arial"/>
              <a:buChar char="•"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r>
              <a:rPr b="0" lang="en-US" sz="54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  <a:p>
            <a:pPr lvl="4" marL="3968640" indent="-439560">
              <a:lnSpc>
                <a:spcPct val="90000"/>
              </a:lnSpc>
              <a:spcBef>
                <a:spcPts val="1925"/>
              </a:spcBef>
              <a:buClr>
                <a:srgbClr val="000000"/>
              </a:buClr>
              <a:buFont typeface="Arial"/>
              <a:buChar char="•"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r>
              <a:rPr b="0" lang="en-US" sz="54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  <a:p>
            <a:pPr lvl="5" marL="3968640" indent="-439560">
              <a:lnSpc>
                <a:spcPct val="90000"/>
              </a:lnSpc>
              <a:spcBef>
                <a:spcPts val="1925"/>
              </a:spcBef>
              <a:buClr>
                <a:srgbClr val="000000"/>
              </a:buClr>
              <a:buFont typeface="Arial"/>
              <a:buChar char="•"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r>
              <a:rPr b="0" lang="en-US" sz="54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  <a:p>
            <a:pPr lvl="6" marL="3968640" indent="-439560">
              <a:lnSpc>
                <a:spcPct val="90000"/>
              </a:lnSpc>
              <a:spcBef>
                <a:spcPts val="1925"/>
              </a:spcBef>
              <a:buClr>
                <a:srgbClr val="000000"/>
              </a:buClr>
              <a:buFont typeface="Arial"/>
              <a:buChar char="•"/>
              <a:tabLst>
                <a:tab algn="l" pos="1763640"/>
                <a:tab algn="l" pos="3527280"/>
                <a:tab algn="l" pos="5291280"/>
                <a:tab algn="l" pos="7054920"/>
                <a:tab algn="l" pos="8818560"/>
                <a:tab algn="l" pos="10582200"/>
              </a:tabLst>
            </a:pPr>
            <a:r>
              <a:rPr b="0" lang="en-US" sz="54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5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212840" y="15016320"/>
            <a:ext cx="3968640" cy="861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300" spc="-1" strike="noStrike">
                <a:solidFill>
                  <a:srgbClr val="898989"/>
                </a:solidFill>
                <a:latin typeface="Calibri"/>
                <a:ea typeface="宋体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300" spc="-1" strike="noStrike">
                <a:solidFill>
                  <a:srgbClr val="898989"/>
                </a:solidFill>
                <a:latin typeface="Calibri"/>
                <a:ea typeface="宋体"/>
              </a:rPr>
              <a:t>&lt;date/time&gt;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5843160" y="15016320"/>
            <a:ext cx="5953320" cy="861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2458880" y="15016320"/>
            <a:ext cx="3968640" cy="861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300" spc="-1" strike="noStrike">
                <a:solidFill>
                  <a:srgbClr val="898989"/>
                </a:solidFill>
                <a:latin typeface="Calibri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B9AB2F-B158-441D-BF33-5A9C2A4CF586}" type="slidenum">
              <a:rPr b="0" lang="en-US" sz="2300" spc="-1" strike="noStrike">
                <a:solidFill>
                  <a:srgbClr val="898989"/>
                </a:solidFill>
                <a:latin typeface="Calibri"/>
                <a:ea typeface="宋体"/>
              </a:rPr>
              <a:t>&lt;number&gt;</a:t>
            </a:fld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png"/><Relationship Id="rId7" Type="http://schemas.openxmlformats.org/officeDocument/2006/relationships/image" Target="../media/image7.jpeg"/><Relationship Id="rId8" Type="http://schemas.openxmlformats.org/officeDocument/2006/relationships/image" Target="../media/image8.pn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oleObject" Target="../embeddings/oleObject1.bin"/><Relationship Id="rId16" Type="http://schemas.openxmlformats.org/officeDocument/2006/relationships/image" Target="../media/image15.wmf"/><Relationship Id="rId17" Type="http://schemas.openxmlformats.org/officeDocument/2006/relationships/oleObject" Target="../embeddings/oleObject2.bin"/><Relationship Id="rId18" Type="http://schemas.openxmlformats.org/officeDocument/2006/relationships/image" Target="../media/image16.wmf"/><Relationship Id="rId19" Type="http://schemas.openxmlformats.org/officeDocument/2006/relationships/slideLayout" Target="../slideLayouts/slideLayout1.xml"/><Relationship Id="rId2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28"/>
          <p:cNvSpPr/>
          <p:nvPr/>
        </p:nvSpPr>
        <p:spPr>
          <a:xfrm rot="16200000">
            <a:off x="566280" y="8980560"/>
            <a:ext cx="951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PBS-NT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本框 133"/>
          <p:cNvSpPr/>
          <p:nvPr/>
        </p:nvSpPr>
        <p:spPr>
          <a:xfrm rot="16200000">
            <a:off x="271800" y="11477160"/>
            <a:ext cx="1519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MOLT4-NT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文本框 135"/>
          <p:cNvSpPr/>
          <p:nvPr/>
        </p:nvSpPr>
        <p:spPr>
          <a:xfrm rot="16200000">
            <a:off x="73440" y="13621680"/>
            <a:ext cx="1973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JURKAT-NT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文本框 136"/>
          <p:cNvSpPr/>
          <p:nvPr/>
        </p:nvSpPr>
        <p:spPr>
          <a:xfrm>
            <a:off x="1709640" y="9012240"/>
            <a:ext cx="4906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PB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文本框 134"/>
          <p:cNvSpPr/>
          <p:nvPr/>
        </p:nvSpPr>
        <p:spPr>
          <a:xfrm>
            <a:off x="2865600" y="7616880"/>
            <a:ext cx="806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Live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本框 137"/>
          <p:cNvSpPr/>
          <p:nvPr/>
        </p:nvSpPr>
        <p:spPr>
          <a:xfrm>
            <a:off x="6630840" y="7566120"/>
            <a:ext cx="1027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Splee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2"/>
          <p:cNvSpPr/>
          <p:nvPr/>
        </p:nvSpPr>
        <p:spPr>
          <a:xfrm>
            <a:off x="384120" y="7416720"/>
            <a:ext cx="2571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5" name="Picture 1" descr=""/>
          <p:cNvPicPr/>
          <p:nvPr/>
        </p:nvPicPr>
        <p:blipFill>
          <a:blip r:embed="rId1"/>
          <a:stretch/>
        </p:blipFill>
        <p:spPr>
          <a:xfrm>
            <a:off x="1393920" y="10385280"/>
            <a:ext cx="3751200" cy="224172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33" descr=""/>
          <p:cNvPicPr/>
          <p:nvPr/>
        </p:nvPicPr>
        <p:blipFill>
          <a:blip r:embed="rId2"/>
          <a:stretch/>
        </p:blipFill>
        <p:spPr>
          <a:xfrm>
            <a:off x="1390680" y="12715920"/>
            <a:ext cx="3757680" cy="233208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2" descr=""/>
          <p:cNvPicPr/>
          <p:nvPr/>
        </p:nvPicPr>
        <p:blipFill>
          <a:blip r:embed="rId3"/>
          <a:stretch/>
        </p:blipFill>
        <p:spPr>
          <a:xfrm>
            <a:off x="5237280" y="7940520"/>
            <a:ext cx="3765600" cy="234324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3" descr=""/>
          <p:cNvPicPr/>
          <p:nvPr/>
        </p:nvPicPr>
        <p:blipFill>
          <a:blip r:embed="rId4"/>
          <a:stretch/>
        </p:blipFill>
        <p:spPr>
          <a:xfrm>
            <a:off x="5237280" y="10385280"/>
            <a:ext cx="3765600" cy="221940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4" descr=""/>
          <p:cNvPicPr/>
          <p:nvPr/>
        </p:nvPicPr>
        <p:blipFill>
          <a:blip r:embed="rId5"/>
          <a:stretch/>
        </p:blipFill>
        <p:spPr>
          <a:xfrm>
            <a:off x="5237280" y="12715920"/>
            <a:ext cx="3765600" cy="233028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2" descr=""/>
          <p:cNvPicPr/>
          <p:nvPr/>
        </p:nvPicPr>
        <p:blipFill>
          <a:blip r:embed="rId6"/>
          <a:stretch/>
        </p:blipFill>
        <p:spPr>
          <a:xfrm>
            <a:off x="1382760" y="7954920"/>
            <a:ext cx="3762360" cy="2341440"/>
          </a:xfrm>
          <a:prstGeom prst="rect">
            <a:avLst/>
          </a:prstGeom>
          <a:ln w="0">
            <a:noFill/>
          </a:ln>
        </p:spPr>
      </p:pic>
      <p:sp>
        <p:nvSpPr>
          <p:cNvPr id="61" name="文本框 10"/>
          <p:cNvSpPr/>
          <p:nvPr/>
        </p:nvSpPr>
        <p:spPr>
          <a:xfrm>
            <a:off x="10674360" y="7594560"/>
            <a:ext cx="187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P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文本框 18"/>
          <p:cNvSpPr/>
          <p:nvPr/>
        </p:nvSpPr>
        <p:spPr>
          <a:xfrm>
            <a:off x="14662080" y="7570800"/>
            <a:ext cx="187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B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3" name="图片 16" descr=""/>
          <p:cNvPicPr/>
          <p:nvPr/>
        </p:nvPicPr>
        <p:blipFill>
          <a:blip r:embed="rId7"/>
          <a:stretch/>
        </p:blipFill>
        <p:spPr>
          <a:xfrm>
            <a:off x="12972960" y="7939080"/>
            <a:ext cx="3792600" cy="2357280"/>
          </a:xfrm>
          <a:prstGeom prst="rect">
            <a:avLst/>
          </a:prstGeom>
          <a:ln w="0">
            <a:noFill/>
          </a:ln>
        </p:spPr>
      </p:pic>
      <p:pic>
        <p:nvPicPr>
          <p:cNvPr id="64" name="图片 11" descr=""/>
          <p:cNvPicPr/>
          <p:nvPr/>
        </p:nvPicPr>
        <p:blipFill>
          <a:blip r:embed="rId8"/>
          <a:stretch/>
        </p:blipFill>
        <p:spPr>
          <a:xfrm>
            <a:off x="12979440" y="10385280"/>
            <a:ext cx="3786120" cy="2238480"/>
          </a:xfrm>
          <a:prstGeom prst="rect">
            <a:avLst/>
          </a:prstGeom>
          <a:ln w="0">
            <a:noFill/>
          </a:ln>
        </p:spPr>
      </p:pic>
      <p:pic>
        <p:nvPicPr>
          <p:cNvPr id="65" name="图片 77" descr=""/>
          <p:cNvPicPr/>
          <p:nvPr/>
        </p:nvPicPr>
        <p:blipFill>
          <a:blip r:embed="rId9"/>
          <a:stretch/>
        </p:blipFill>
        <p:spPr>
          <a:xfrm>
            <a:off x="12972960" y="12701520"/>
            <a:ext cx="3792600" cy="2344680"/>
          </a:xfrm>
          <a:prstGeom prst="rect">
            <a:avLst/>
          </a:prstGeom>
          <a:ln w="0">
            <a:noFill/>
          </a:ln>
        </p:spPr>
      </p:pic>
      <p:pic>
        <p:nvPicPr>
          <p:cNvPr id="66" name="图片 81" descr=""/>
          <p:cNvPicPr/>
          <p:nvPr/>
        </p:nvPicPr>
        <p:blipFill>
          <a:blip r:embed="rId10"/>
          <a:stretch/>
        </p:blipFill>
        <p:spPr>
          <a:xfrm>
            <a:off x="9091440" y="10396440"/>
            <a:ext cx="3757680" cy="2208240"/>
          </a:xfrm>
          <a:prstGeom prst="rect">
            <a:avLst/>
          </a:prstGeom>
          <a:ln w="0">
            <a:noFill/>
          </a:ln>
        </p:spPr>
      </p:pic>
      <p:pic>
        <p:nvPicPr>
          <p:cNvPr id="67" name="图片 83" descr=""/>
          <p:cNvPicPr/>
          <p:nvPr/>
        </p:nvPicPr>
        <p:blipFill>
          <a:blip r:embed="rId11"/>
          <a:stretch/>
        </p:blipFill>
        <p:spPr>
          <a:xfrm>
            <a:off x="9091440" y="12715920"/>
            <a:ext cx="3757680" cy="2327400"/>
          </a:xfrm>
          <a:prstGeom prst="rect">
            <a:avLst/>
          </a:prstGeom>
          <a:ln w="0">
            <a:noFill/>
          </a:ln>
        </p:spPr>
      </p:pic>
      <p:pic>
        <p:nvPicPr>
          <p:cNvPr id="68" name="图片 85" descr=""/>
          <p:cNvPicPr/>
          <p:nvPr/>
        </p:nvPicPr>
        <p:blipFill>
          <a:blip r:embed="rId12"/>
          <a:stretch/>
        </p:blipFill>
        <p:spPr>
          <a:xfrm>
            <a:off x="9115560" y="7939080"/>
            <a:ext cx="3733560" cy="2357280"/>
          </a:xfrm>
          <a:prstGeom prst="rect">
            <a:avLst/>
          </a:prstGeom>
          <a:ln w="0">
            <a:noFill/>
          </a:ln>
        </p:spPr>
      </p:pic>
      <p:pic>
        <p:nvPicPr>
          <p:cNvPr id="69" name="图片 126" descr=""/>
          <p:cNvPicPr/>
          <p:nvPr/>
        </p:nvPicPr>
        <p:blipFill>
          <a:blip r:embed="rId13"/>
          <a:srcRect l="10712" t="64706" r="22195" b="20794"/>
          <a:stretch/>
        </p:blipFill>
        <p:spPr>
          <a:xfrm>
            <a:off x="2968560" y="1847880"/>
            <a:ext cx="4748400" cy="1425600"/>
          </a:xfrm>
          <a:prstGeom prst="rect">
            <a:avLst/>
          </a:prstGeom>
          <a:ln w="0">
            <a:noFill/>
          </a:ln>
        </p:spPr>
      </p:pic>
      <p:pic>
        <p:nvPicPr>
          <p:cNvPr id="70" name="图片 129" descr=""/>
          <p:cNvPicPr/>
          <p:nvPr/>
        </p:nvPicPr>
        <p:blipFill>
          <a:blip r:embed="rId14"/>
          <a:srcRect l="18217" t="62632" r="20981" b="12586"/>
          <a:stretch/>
        </p:blipFill>
        <p:spPr>
          <a:xfrm>
            <a:off x="9374040" y="1847880"/>
            <a:ext cx="4746600" cy="1425600"/>
          </a:xfrm>
          <a:prstGeom prst="rect">
            <a:avLst/>
          </a:prstGeom>
          <a:ln w="0">
            <a:noFill/>
          </a:ln>
        </p:spPr>
      </p:pic>
      <p:sp>
        <p:nvSpPr>
          <p:cNvPr id="71" name="文本框 54"/>
          <p:cNvSpPr/>
          <p:nvPr/>
        </p:nvSpPr>
        <p:spPr>
          <a:xfrm>
            <a:off x="2505240" y="858960"/>
            <a:ext cx="510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5"/>
          <p:cNvSpPr/>
          <p:nvPr/>
        </p:nvSpPr>
        <p:spPr>
          <a:xfrm>
            <a:off x="5025960" y="950760"/>
            <a:ext cx="1328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Splee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67"/>
          <p:cNvSpPr/>
          <p:nvPr/>
        </p:nvSpPr>
        <p:spPr>
          <a:xfrm>
            <a:off x="3524400" y="1450800"/>
            <a:ext cx="1328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PBS-NT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68"/>
          <p:cNvSpPr/>
          <p:nvPr/>
        </p:nvSpPr>
        <p:spPr>
          <a:xfrm>
            <a:off x="4822920" y="1450800"/>
            <a:ext cx="1330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MOLT4-NT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69"/>
          <p:cNvSpPr/>
          <p:nvPr/>
        </p:nvSpPr>
        <p:spPr>
          <a:xfrm>
            <a:off x="6453360" y="1450800"/>
            <a:ext cx="1512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JURKAT-NT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70"/>
          <p:cNvSpPr/>
          <p:nvPr/>
        </p:nvSpPr>
        <p:spPr>
          <a:xfrm>
            <a:off x="11676240" y="950760"/>
            <a:ext cx="1328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Live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71"/>
          <p:cNvSpPr/>
          <p:nvPr/>
        </p:nvSpPr>
        <p:spPr>
          <a:xfrm>
            <a:off x="9871200" y="1449360"/>
            <a:ext cx="1328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PBS-NT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72"/>
          <p:cNvSpPr/>
          <p:nvPr/>
        </p:nvSpPr>
        <p:spPr>
          <a:xfrm>
            <a:off x="11182320" y="1447920"/>
            <a:ext cx="1330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MOLT4-NT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73"/>
          <p:cNvSpPr/>
          <p:nvPr/>
        </p:nvSpPr>
        <p:spPr>
          <a:xfrm>
            <a:off x="12835080" y="1447920"/>
            <a:ext cx="1512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JURKAT-NT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80" name="Object 2"/>
          <p:cNvGraphicFramePr/>
          <p:nvPr/>
        </p:nvGraphicFramePr>
        <p:xfrm>
          <a:off x="3359160" y="3429000"/>
          <a:ext cx="3867120" cy="366084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81" name="Object 2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3359160" y="3429000"/>
                    <a:ext cx="3867120" cy="3660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2" name="Object 3"/>
          <p:cNvGraphicFramePr/>
          <p:nvPr/>
        </p:nvGraphicFramePr>
        <p:xfrm>
          <a:off x="9720360" y="3390840"/>
          <a:ext cx="4110120" cy="374328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83" name="Object 3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9720360" y="3390840"/>
                    <a:ext cx="4110120" cy="3743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4" name="TextBox 1"/>
          <p:cNvSpPr/>
          <p:nvPr/>
        </p:nvSpPr>
        <p:spPr>
          <a:xfrm>
            <a:off x="4627440" y="10023480"/>
            <a:ext cx="8082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37"/>
          <p:cNvSpPr/>
          <p:nvPr/>
        </p:nvSpPr>
        <p:spPr>
          <a:xfrm>
            <a:off x="8510760" y="10023480"/>
            <a:ext cx="8078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38"/>
          <p:cNvSpPr/>
          <p:nvPr/>
        </p:nvSpPr>
        <p:spPr>
          <a:xfrm>
            <a:off x="12349080" y="10039320"/>
            <a:ext cx="8082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39"/>
          <p:cNvSpPr/>
          <p:nvPr/>
        </p:nvSpPr>
        <p:spPr>
          <a:xfrm>
            <a:off x="16230600" y="10023480"/>
            <a:ext cx="809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41"/>
          <p:cNvSpPr/>
          <p:nvPr/>
        </p:nvSpPr>
        <p:spPr>
          <a:xfrm>
            <a:off x="4645080" y="12350880"/>
            <a:ext cx="8078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42"/>
          <p:cNvSpPr/>
          <p:nvPr/>
        </p:nvSpPr>
        <p:spPr>
          <a:xfrm>
            <a:off x="8510760" y="12315960"/>
            <a:ext cx="8078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43"/>
          <p:cNvSpPr/>
          <p:nvPr/>
        </p:nvSpPr>
        <p:spPr>
          <a:xfrm>
            <a:off x="12331800" y="12366720"/>
            <a:ext cx="8078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44"/>
          <p:cNvSpPr/>
          <p:nvPr/>
        </p:nvSpPr>
        <p:spPr>
          <a:xfrm>
            <a:off x="16230600" y="12350880"/>
            <a:ext cx="809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45"/>
          <p:cNvSpPr/>
          <p:nvPr/>
        </p:nvSpPr>
        <p:spPr>
          <a:xfrm>
            <a:off x="4675320" y="14774760"/>
            <a:ext cx="8078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46"/>
          <p:cNvSpPr/>
          <p:nvPr/>
        </p:nvSpPr>
        <p:spPr>
          <a:xfrm>
            <a:off x="8537400" y="14720760"/>
            <a:ext cx="8082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47"/>
          <p:cNvSpPr/>
          <p:nvPr/>
        </p:nvSpPr>
        <p:spPr>
          <a:xfrm>
            <a:off x="12379320" y="14754240"/>
            <a:ext cx="8082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48"/>
          <p:cNvSpPr/>
          <p:nvPr/>
        </p:nvSpPr>
        <p:spPr>
          <a:xfrm>
            <a:off x="16260840" y="14755680"/>
            <a:ext cx="8078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宋体"/>
              </a:rPr>
              <a:t>20µ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文本框 54"/>
          <p:cNvSpPr/>
          <p:nvPr/>
        </p:nvSpPr>
        <p:spPr>
          <a:xfrm>
            <a:off x="9001080" y="863640"/>
            <a:ext cx="511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7-02T17:20:30Z</dcterms:created>
  <dc:creator>Microsoft account</dc:creator>
  <dc:description/>
  <dc:language>en-US</dc:language>
  <cp:lastModifiedBy>Microsoft account</cp:lastModifiedBy>
  <dcterms:modified xsi:type="dcterms:W3CDTF">2023-04-12T20:15:57Z</dcterms:modified>
  <cp:revision>87</cp:revision>
  <dc:subject/>
  <dc:title>PowerPoint Presentation</dc:title>
</cp:coreProperties>
</file>